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6"/>
  </p:notesMasterIdLst>
  <p:sldIdLst>
    <p:sldId id="256" r:id="rId2"/>
    <p:sldId id="258" r:id="rId3"/>
    <p:sldId id="259" r:id="rId4"/>
    <p:sldId id="260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295"/>
    <p:restoredTop sz="94694"/>
  </p:normalViewPr>
  <p:slideViewPr>
    <p:cSldViewPr snapToGrid="0" snapToObjects="1">
      <p:cViewPr varScale="1">
        <p:scale>
          <a:sx n="121" d="100"/>
          <a:sy n="121" d="100"/>
        </p:scale>
        <p:origin x="82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5044820-65F6-FB4B-88F8-E36D76D80BC6}" type="datetimeFigureOut">
              <a:rPr lang="en-GB" smtClean="0"/>
              <a:t>16/04/2021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DCB6602-CF93-284D-8469-CD9FC26B73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070184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A)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icrometastasis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with a diameter of 303,94 um, which was overlooked on histological examination but detected by PCR examination. (x40) (H&amp;E stain), inset: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icrometastasis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 high magnification (x200) (H&amp;E stain)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DCB6602-CF93-284D-8469-CD9FC26B732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766025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B) CK19 IHC staining of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icrometastasis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(x40), inset: CK19 positivity in high magnification (x200).</a:t>
            </a:r>
            <a:r>
              <a:rPr lang="en-GB">
                <a:effectLst/>
              </a:rPr>
              <a:t> </a:t>
            </a:r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DCB6602-CF93-284D-8469-CD9FC26B7325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983533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A) Mesothelial epithelial lining on the outside of the lymph node (x200) (H&amp;E stain), 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DCB6602-CF93-284D-8469-CD9FC26B7325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246839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B) CK19 IHC staining in mesothelial cells (x200) </a:t>
            </a:r>
            <a:endParaRPr lang="en-GB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DCB6602-CF93-284D-8469-CD9FC26B7325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3825083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29A10F-C035-854C-AA24-50F2A9CDCCF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1037247-DDD1-9A45-B5DC-7D816AC3B96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CC2F1F0-400B-1E4D-8FA2-75817BF4D5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EC92CC-7BD9-7348-A88A-9B922ED7D7DA}" type="datetimeFigureOut">
              <a:rPr lang="en-GB" smtClean="0"/>
              <a:t>16/04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581CB07-D06C-0246-ADD9-568C1FC781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07A47DE-7B09-9945-9631-38967797B8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648293-B86C-B441-8579-D25F22574F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332522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16C6BB-244F-9B40-B18D-E60D1E153D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4489F8C-355F-5746-8640-F32AA5CAAA1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B62EFC8-AA08-AA48-8EAB-F746A64381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EC92CC-7BD9-7348-A88A-9B922ED7D7DA}" type="datetimeFigureOut">
              <a:rPr lang="en-GB" smtClean="0"/>
              <a:t>16/04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DB37E3F-424C-7B4C-965E-25420304F6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A24E3E5-7E1F-0742-A0DF-647A07EBFF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648293-B86C-B441-8579-D25F22574F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520702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C2FD5A3-990F-F14F-AE12-6FE74817D6F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94A438C-F530-894C-B58A-4385672FC0A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7BF8A76-380C-C74E-95F6-0BFFEE5F8E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EC92CC-7BD9-7348-A88A-9B922ED7D7DA}" type="datetimeFigureOut">
              <a:rPr lang="en-GB" smtClean="0"/>
              <a:t>16/04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B256D03-0104-AF47-94CB-63DC174F6C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630DFDC-F078-964B-B08A-3D2F4C08BF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648293-B86C-B441-8579-D25F22574F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204853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4F070B-3B27-6145-ACC3-103D5873AA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7E138EF-FF12-7642-BF90-1B2A13ED73E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5C58DF6-BAE2-E645-AB46-5F8D38F017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EC92CC-7BD9-7348-A88A-9B922ED7D7DA}" type="datetimeFigureOut">
              <a:rPr lang="en-GB" smtClean="0"/>
              <a:t>16/04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4BF8C6F-96D0-C743-8CD3-76C3EC19FB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6AF18FB-18DE-414B-A6CF-BD6DD00226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648293-B86C-B441-8579-D25F22574F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652061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B44269-1FB4-FC4F-ADBB-23FCB2A67B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93B0B71-3A8E-1E42-ABF9-63CA2F79C82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4B3BD41-04D8-5846-AF70-90F9FC993D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EC92CC-7BD9-7348-A88A-9B922ED7D7DA}" type="datetimeFigureOut">
              <a:rPr lang="en-GB" smtClean="0"/>
              <a:t>16/04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4D069CA-D550-F14A-A1B1-7A55419EEB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B2A4E12-484D-634B-8E4C-F44A37C565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648293-B86C-B441-8579-D25F22574F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771295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F759BD-E1FD-544C-8A84-3324CBFA3E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35F3AA4-DFC5-C143-B365-71AF202E4AC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62B9257-761A-2A45-B7E1-E8FDB41B3F0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5764689-1948-0143-A498-3D494BFBE9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EC92CC-7BD9-7348-A88A-9B922ED7D7DA}" type="datetimeFigureOut">
              <a:rPr lang="en-GB" smtClean="0"/>
              <a:t>16/04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D711B63-13C2-7C49-8DAE-B210E14D50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70D0975-76D0-B044-87B8-5F5E61F2CA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648293-B86C-B441-8579-D25F22574F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047305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94F3DF-8EF1-5C48-BC48-48CA6B62B0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88293A3-8F71-D74E-B1D7-6522ED5D6A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3BE9782-63FE-1E45-8BA7-68A602B052F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7B2A31A-5BDF-DD4A-BF6F-58774001488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2A25FC8-45E7-A440-AAEF-17D4721F503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26D3562-3E4F-624C-A26C-013EC70026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EC92CC-7BD9-7348-A88A-9B922ED7D7DA}" type="datetimeFigureOut">
              <a:rPr lang="en-GB" smtClean="0"/>
              <a:t>16/04/2021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ECAFFB0-8569-AA4D-BED8-30DA3B31C1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D3C05D0-AC87-AC44-904B-4DACA74DBE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648293-B86C-B441-8579-D25F22574F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971848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1A109B-2A14-EC49-98C1-550485F444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B7FB9E0-415E-3C4A-85E8-CF6F03C185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EC92CC-7BD9-7348-A88A-9B922ED7D7DA}" type="datetimeFigureOut">
              <a:rPr lang="en-GB" smtClean="0"/>
              <a:t>16/04/2021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E9C273E-938D-E14E-AD18-6E24E3E07A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342011E-2887-C441-897B-B73569A0AC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648293-B86C-B441-8579-D25F22574F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883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211E4C9-3527-4340-BFAD-F6185D6EAD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EC92CC-7BD9-7348-A88A-9B922ED7D7DA}" type="datetimeFigureOut">
              <a:rPr lang="en-GB" smtClean="0"/>
              <a:t>16/04/2021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9FF43FE-217B-AF46-AB25-1F341DCDF8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8C1DD24-B949-9444-8B72-397A189E9D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648293-B86C-B441-8579-D25F22574F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949724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FF3EE0-444B-1445-8F06-2C676276A2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76F0CBE-8B66-5043-AFDA-205DD6602E3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53618CD-A280-D44D-B690-F27B8CE0A40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3D1F916-B81E-0641-94FA-79901CF3A2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EC92CC-7BD9-7348-A88A-9B922ED7D7DA}" type="datetimeFigureOut">
              <a:rPr lang="en-GB" smtClean="0"/>
              <a:t>16/04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D89C653-B4CD-A547-A5DD-182AD5F748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F1A2019-3677-0A4F-885C-B400B491F0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648293-B86C-B441-8579-D25F22574F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190258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971121-FE9D-DF4C-8C52-52785AE457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77B0F4D-6E7A-1840-AA39-CF95520C666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A3B92CB-110E-1942-B919-7FB1B239BFD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C6A212A-E856-1C46-B702-0FD32A7C52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EC92CC-7BD9-7348-A88A-9B922ED7D7DA}" type="datetimeFigureOut">
              <a:rPr lang="en-GB" smtClean="0"/>
              <a:t>16/04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D7368AD-5C62-E545-9A85-71FC77A37B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24C9E81-D6BB-8640-9A8C-48B0700E92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648293-B86C-B441-8579-D25F22574F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387876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6106588-09D9-0740-A2FF-539FC4FDE9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F364F55-E6AF-034F-9EFC-99296D6B833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E655725-5502-8443-A650-9FD0E3E1BB3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EC92CC-7BD9-7348-A88A-9B922ED7D7DA}" type="datetimeFigureOut">
              <a:rPr lang="en-GB" smtClean="0"/>
              <a:t>16/04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1CD163B-5DD5-5F46-9A54-86615BC2CE4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342C055-676D-C849-BBA1-96460DC6384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648293-B86C-B441-8579-D25F22574FD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514013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jp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D9C1E9AF-8762-3249-9CD1-90E30AE4FA3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22092" y="0"/>
            <a:ext cx="9147816" cy="68580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8C2F448E-0D18-C145-BBC2-D17F0685584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529959" y="2989238"/>
            <a:ext cx="5078405" cy="3807215"/>
          </a:xfrm>
          <a:prstGeom prst="rect">
            <a:avLst/>
          </a:prstGeom>
          <a:ln w="57150">
            <a:solidFill>
              <a:schemeClr val="tx1"/>
            </a:solidFill>
          </a:ln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A54C0FD6-4E36-994D-932D-F3321F5D460B}"/>
              </a:ext>
            </a:extLst>
          </p:cNvPr>
          <p:cNvSpPr txBox="1"/>
          <p:nvPr/>
        </p:nvSpPr>
        <p:spPr>
          <a:xfrm>
            <a:off x="2637693" y="1424354"/>
            <a:ext cx="1582616" cy="1310054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en-GB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2DF2CFE-2AFC-294F-8E65-153C8A7A17C0}"/>
              </a:ext>
            </a:extLst>
          </p:cNvPr>
          <p:cNvSpPr txBox="1"/>
          <p:nvPr/>
        </p:nvSpPr>
        <p:spPr>
          <a:xfrm>
            <a:off x="1682496" y="164592"/>
            <a:ext cx="58521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b="1" dirty="0">
                <a:latin typeface="Calibri" panose="020F0502020204030204" pitchFamily="34" charset="0"/>
                <a:cs typeface="Calibri" panose="020F0502020204030204" pitchFamily="34" charset="0"/>
              </a:rPr>
              <a:t>A</a:t>
            </a:r>
            <a:endParaRPr lang="en-GB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B5A4C5F0-B20D-4B4E-ACF8-EB927A7D1BD9}"/>
              </a:ext>
            </a:extLst>
          </p:cNvPr>
          <p:cNvSpPr txBox="1"/>
          <p:nvPr/>
        </p:nvSpPr>
        <p:spPr>
          <a:xfrm rot="16200000">
            <a:off x="-2126999" y="4220362"/>
            <a:ext cx="47828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upplementary Figure 1 (A)</a:t>
            </a:r>
          </a:p>
        </p:txBody>
      </p:sp>
    </p:spTree>
    <p:extLst>
      <p:ext uri="{BB962C8B-B14F-4D97-AF65-F5344CB8AC3E}">
        <p14:creationId xmlns:p14="http://schemas.microsoft.com/office/powerpoint/2010/main" val="387288121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>
            <a:extLst>
              <a:ext uri="{FF2B5EF4-FFF2-40B4-BE49-F238E27FC236}">
                <a16:creationId xmlns:a16="http://schemas.microsoft.com/office/drawing/2014/main" id="{7C54DFEE-56B0-534E-B835-881A346D490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16115" y="0"/>
            <a:ext cx="9147816" cy="6858000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A54C0FD6-4E36-994D-932D-F3321F5D460B}"/>
              </a:ext>
            </a:extLst>
          </p:cNvPr>
          <p:cNvSpPr txBox="1"/>
          <p:nvPr/>
        </p:nvSpPr>
        <p:spPr>
          <a:xfrm>
            <a:off x="4219605" y="2118946"/>
            <a:ext cx="1582616" cy="1310054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en-GB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2DF2CFE-2AFC-294F-8E65-153C8A7A17C0}"/>
              </a:ext>
            </a:extLst>
          </p:cNvPr>
          <p:cNvSpPr txBox="1"/>
          <p:nvPr/>
        </p:nvSpPr>
        <p:spPr>
          <a:xfrm>
            <a:off x="1682496" y="164592"/>
            <a:ext cx="58521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b="1" dirty="0">
                <a:latin typeface="Calibri" panose="020F0502020204030204" pitchFamily="34" charset="0"/>
                <a:cs typeface="Calibri" panose="020F0502020204030204" pitchFamily="34" charset="0"/>
              </a:rPr>
              <a:t>B</a:t>
            </a:r>
            <a:endParaRPr lang="en-GB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32221353-8BBF-E746-A911-179F939CC75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016402" y="3340730"/>
            <a:ext cx="4585633" cy="3437790"/>
          </a:xfrm>
          <a:prstGeom prst="rect">
            <a:avLst/>
          </a:prstGeom>
          <a:ln w="57150">
            <a:solidFill>
              <a:schemeClr val="tx1"/>
            </a:solidFill>
          </a:ln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8542AC0E-879C-4E49-A603-35DA2B96667C}"/>
              </a:ext>
            </a:extLst>
          </p:cNvPr>
          <p:cNvSpPr txBox="1"/>
          <p:nvPr/>
        </p:nvSpPr>
        <p:spPr>
          <a:xfrm rot="16200000">
            <a:off x="-2126999" y="4220362"/>
            <a:ext cx="47828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upplementary Figure 1 (B)</a:t>
            </a:r>
          </a:p>
        </p:txBody>
      </p:sp>
    </p:spTree>
    <p:extLst>
      <p:ext uri="{BB962C8B-B14F-4D97-AF65-F5344CB8AC3E}">
        <p14:creationId xmlns:p14="http://schemas.microsoft.com/office/powerpoint/2010/main" val="191737213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DE8A51D5-CF7D-1744-A5F6-826B133D477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22092" y="0"/>
            <a:ext cx="9147816" cy="6858000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22DF2CFE-2AFC-294F-8E65-153C8A7A17C0}"/>
              </a:ext>
            </a:extLst>
          </p:cNvPr>
          <p:cNvSpPr txBox="1"/>
          <p:nvPr/>
        </p:nvSpPr>
        <p:spPr>
          <a:xfrm>
            <a:off x="1682496" y="164592"/>
            <a:ext cx="58521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b="1" dirty="0">
                <a:latin typeface="Calibri" panose="020F0502020204030204" pitchFamily="34" charset="0"/>
                <a:cs typeface="Calibri" panose="020F0502020204030204" pitchFamily="34" charset="0"/>
              </a:rPr>
              <a:t>A</a:t>
            </a:r>
            <a:endParaRPr lang="en-GB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DAEAFA7-CA43-3748-B14D-8D6495D3EF95}"/>
              </a:ext>
            </a:extLst>
          </p:cNvPr>
          <p:cNvSpPr txBox="1"/>
          <p:nvPr/>
        </p:nvSpPr>
        <p:spPr>
          <a:xfrm rot="16200000">
            <a:off x="-2126999" y="4220362"/>
            <a:ext cx="47828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upplementary Figure 2 (A)</a:t>
            </a:r>
          </a:p>
        </p:txBody>
      </p:sp>
    </p:spTree>
    <p:extLst>
      <p:ext uri="{BB962C8B-B14F-4D97-AF65-F5344CB8AC3E}">
        <p14:creationId xmlns:p14="http://schemas.microsoft.com/office/powerpoint/2010/main" val="226619713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58FA4D72-3352-6442-B16B-4369FD21FA8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22092" y="0"/>
            <a:ext cx="9147816" cy="6858000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22DF2CFE-2AFC-294F-8E65-153C8A7A17C0}"/>
              </a:ext>
            </a:extLst>
          </p:cNvPr>
          <p:cNvSpPr txBox="1"/>
          <p:nvPr/>
        </p:nvSpPr>
        <p:spPr>
          <a:xfrm>
            <a:off x="1682496" y="164592"/>
            <a:ext cx="58521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b="1" dirty="0">
                <a:latin typeface="Calibri" panose="020F0502020204030204" pitchFamily="34" charset="0"/>
                <a:cs typeface="Calibri" panose="020F0502020204030204" pitchFamily="34" charset="0"/>
              </a:rPr>
              <a:t>B</a:t>
            </a:r>
            <a:endParaRPr lang="en-GB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2E8B616-88DC-5C42-99BB-4AAC214529E9}"/>
              </a:ext>
            </a:extLst>
          </p:cNvPr>
          <p:cNvSpPr txBox="1"/>
          <p:nvPr/>
        </p:nvSpPr>
        <p:spPr>
          <a:xfrm rot="16200000">
            <a:off x="-2126999" y="4220362"/>
            <a:ext cx="47828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upplementary Figure 2 (B)</a:t>
            </a:r>
          </a:p>
        </p:txBody>
      </p:sp>
    </p:spTree>
    <p:extLst>
      <p:ext uri="{BB962C8B-B14F-4D97-AF65-F5344CB8AC3E}">
        <p14:creationId xmlns:p14="http://schemas.microsoft.com/office/powerpoint/2010/main" val="9143049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1</TotalTime>
  <Words>134</Words>
  <Application>Microsoft Macintosh PowerPoint</Application>
  <PresentationFormat>Widescreen</PresentationFormat>
  <Paragraphs>16</Paragraphs>
  <Slides>4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NDE SUER</dc:creator>
  <cp:lastModifiedBy>HANDE SUER</cp:lastModifiedBy>
  <cp:revision>4</cp:revision>
  <dcterms:created xsi:type="dcterms:W3CDTF">2021-03-30T19:05:38Z</dcterms:created>
  <dcterms:modified xsi:type="dcterms:W3CDTF">2021-04-16T14:43:59Z</dcterms:modified>
</cp:coreProperties>
</file>